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3BD4E1-835E-4565-9754-23CF9D02D0A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EFC3A1-3786-4FC9-BB26-9255176E59A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BDE5AE-D5C3-45EE-9F3C-CCE58309A30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69D051-A962-48A8-A555-F64FBBB6539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F9C4CA-E94A-4A66-8643-1D2165093AD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2D91C1-7740-4ED0-BBBA-C2B4455669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B2FF1E-E2F0-47C0-AE29-293055BEF0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BCC39C-8D21-45BD-9ED1-33EA1CD8D3F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FDAA1A-AD2B-4AEC-9755-7F3AE70027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0E695B-37B8-4E84-BC7E-B6B19F83F3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9712BD-99C0-4B1D-A9A7-573E348C8B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116CFF-EC29-4B46-AB39-F322FC7EB7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C69C1B2-65B9-4547-8800-2335601919B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"/>
          <p:cNvSpPr/>
          <p:nvPr/>
        </p:nvSpPr>
        <p:spPr>
          <a:xfrm>
            <a:off x="247680" y="285840"/>
            <a:ext cx="7495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5A. Bias plots for Marioni data using procedures 2, gene level ENS48 annotation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3" descr=""/>
          <p:cNvPicPr/>
          <p:nvPr/>
        </p:nvPicPr>
        <p:blipFill>
          <a:blip r:embed="rId1"/>
          <a:stretch/>
        </p:blipFill>
        <p:spPr>
          <a:xfrm>
            <a:off x="285840" y="928800"/>
            <a:ext cx="8512200" cy="4922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TextBox 2"/>
          <p:cNvSpPr/>
          <p:nvPr/>
        </p:nvSpPr>
        <p:spPr>
          <a:xfrm>
            <a:off x="245160" y="285840"/>
            <a:ext cx="6046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5B. Bias plots for Marioni data using procedures 3, gene level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4" name="Picture 2" descr=""/>
          <p:cNvPicPr/>
          <p:nvPr/>
        </p:nvPicPr>
        <p:blipFill>
          <a:blip r:embed="rId1"/>
          <a:stretch/>
        </p:blipFill>
        <p:spPr>
          <a:xfrm>
            <a:off x="285840" y="863640"/>
            <a:ext cx="8480160" cy="4922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06T17:25:21Z</dcterms:created>
  <dc:creator>Wei Zheng</dc:creator>
  <dc:description/>
  <dc:language>en-US</dc:language>
  <cp:lastModifiedBy>Wei Zheng</cp:lastModifiedBy>
  <dcterms:modified xsi:type="dcterms:W3CDTF">2011-06-06T17:26:18Z</dcterms:modified>
  <cp:revision>1</cp:revision>
  <dc:subject/>
  <dc:title>Slide 1</dc:title>
</cp:coreProperties>
</file>